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05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84934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2257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63816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4952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03992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6528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4916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49558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19947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2442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17726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E9047E-CFA1-431A-A1F9-1D09077A49D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8090E-C3C9-430B-9CCE-A52D073B536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5193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0" y="5564152"/>
            <a:ext cx="8436634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spAutoFit/>
          </a:bodyPr>
          <a:lstStyle/>
          <a:p>
            <a:pPr marL="447675" indent="-447675"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6:  </a:t>
            </a:r>
            <a:r>
              <a:rPr lang="en-P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</a:t>
            </a:r>
            <a:r>
              <a:rPr lang="en-P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TLs detected from 357 BC</a:t>
            </a:r>
            <a:r>
              <a:rPr lang="en-PH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P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PH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P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types derived from an IR64 × OL cross conferring (a &amp; b) style length, (c) stigma breadth, (d) stigma area, and (e) pistil length using 164 SSR and STS markers.</a:t>
            </a:r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45720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-76200" y="718067"/>
            <a:ext cx="1843675" cy="4062617"/>
            <a:chOff x="-152398" y="457200"/>
            <a:chExt cx="2921867" cy="5264266"/>
          </a:xfrm>
        </p:grpSpPr>
        <p:pic>
          <p:nvPicPr>
            <p:cNvPr id="7" name="Picture 29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26" t="14120" r="50404" b="10611"/>
            <a:stretch>
              <a:fillRect/>
            </a:stretch>
          </p:blipFill>
          <p:spPr bwMode="auto">
            <a:xfrm>
              <a:off x="1067036" y="653904"/>
              <a:ext cx="1702433" cy="50675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29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936" r="85114" b="10811"/>
            <a:stretch>
              <a:fillRect/>
            </a:stretch>
          </p:blipFill>
          <p:spPr bwMode="auto">
            <a:xfrm>
              <a:off x="-152398" y="457200"/>
              <a:ext cx="1271195" cy="52435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9" name="Group 8"/>
          <p:cNvGrpSpPr/>
          <p:nvPr/>
        </p:nvGrpSpPr>
        <p:grpSpPr>
          <a:xfrm>
            <a:off x="4070754" y="618950"/>
            <a:ext cx="1702096" cy="4170174"/>
            <a:chOff x="4388922" y="443344"/>
            <a:chExt cx="3894104" cy="5372501"/>
          </a:xfrm>
        </p:grpSpPr>
        <p:pic>
          <p:nvPicPr>
            <p:cNvPr id="10" name="Picture 29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080" t="14885" r="24814" b="13394"/>
            <a:stretch>
              <a:fillRect/>
            </a:stretch>
          </p:blipFill>
          <p:spPr bwMode="auto">
            <a:xfrm>
              <a:off x="5878287" y="789356"/>
              <a:ext cx="2404739" cy="502648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29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872" t="10497" r="36423" b="12856"/>
            <a:stretch>
              <a:fillRect/>
            </a:stretch>
          </p:blipFill>
          <p:spPr bwMode="auto">
            <a:xfrm>
              <a:off x="4388922" y="443344"/>
              <a:ext cx="1326078" cy="53725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12" name="Picture 11"/>
          <p:cNvPicPr/>
          <p:nvPr/>
        </p:nvPicPr>
        <p:blipFill rotWithShape="1">
          <a:blip r:embed="rId3" cstate="print"/>
          <a:srcRect l="89284" t="15130" r="1092" b="36632"/>
          <a:stretch>
            <a:fillRect/>
          </a:stretch>
        </p:blipFill>
        <p:spPr bwMode="auto">
          <a:xfrm>
            <a:off x="7867434" y="1207008"/>
            <a:ext cx="1122947" cy="2898812"/>
          </a:xfrm>
          <a:prstGeom prst="rect">
            <a:avLst/>
          </a:prstGeom>
          <a:noFill/>
        </p:spPr>
      </p:pic>
      <p:pic>
        <p:nvPicPr>
          <p:cNvPr id="13" name="Picture 12"/>
          <p:cNvPicPr/>
          <p:nvPr/>
        </p:nvPicPr>
        <p:blipFill rotWithShape="1">
          <a:blip r:embed="rId3" cstate="print"/>
          <a:srcRect l="74042" t="13023" r="12979" b="36632"/>
          <a:stretch>
            <a:fillRect/>
          </a:stretch>
        </p:blipFill>
        <p:spPr bwMode="auto">
          <a:xfrm>
            <a:off x="7349964" y="1028699"/>
            <a:ext cx="537684" cy="3048002"/>
          </a:xfrm>
          <a:prstGeom prst="rect">
            <a:avLst/>
          </a:prstGeom>
          <a:noFill/>
        </p:spPr>
      </p:pic>
      <p:sp>
        <p:nvSpPr>
          <p:cNvPr id="14" name="TextBox 13"/>
          <p:cNvSpPr txBox="1"/>
          <p:nvPr/>
        </p:nvSpPr>
        <p:spPr>
          <a:xfrm rot="10800000">
            <a:off x="578259" y="760142"/>
            <a:ext cx="1198533" cy="369332"/>
          </a:xfrm>
          <a:prstGeom prst="rect">
            <a:avLst/>
          </a:prstGeom>
          <a:noFill/>
        </p:spPr>
        <p:txBody>
          <a:bodyPr vert="vert270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</a:t>
            </a:r>
          </a:p>
        </p:txBody>
      </p:sp>
      <p:sp>
        <p:nvSpPr>
          <p:cNvPr id="15" name="TextBox 14"/>
          <p:cNvSpPr txBox="1"/>
          <p:nvPr/>
        </p:nvSpPr>
        <p:spPr>
          <a:xfrm rot="10800000">
            <a:off x="4629060" y="600977"/>
            <a:ext cx="1132041" cy="369332"/>
          </a:xfrm>
          <a:prstGeom prst="rect">
            <a:avLst/>
          </a:prstGeom>
          <a:noFill/>
        </p:spPr>
        <p:txBody>
          <a:bodyPr vert="vert270" wrap="square" rtlCol="0" anchor="b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  <a:p>
            <a:pPr algn="ctr">
              <a:lnSpc>
                <a:spcPct val="150000"/>
              </a:lnSpc>
            </a:pP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  <a:p>
            <a:pPr algn="ctr">
              <a:lnSpc>
                <a:spcPct val="150000"/>
              </a:lnSpc>
            </a:pP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  <a:p>
            <a:pPr algn="ctr">
              <a:lnSpc>
                <a:spcPct val="150000"/>
              </a:lnSpc>
            </a:pP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  <a:p>
            <a:pPr algn="ctr">
              <a:lnSpc>
                <a:spcPct val="200000"/>
              </a:lnSpc>
            </a:pP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</a:t>
            </a:r>
          </a:p>
        </p:txBody>
      </p:sp>
      <p:sp>
        <p:nvSpPr>
          <p:cNvPr id="16" name="TextBox 15"/>
          <p:cNvSpPr txBox="1"/>
          <p:nvPr/>
        </p:nvSpPr>
        <p:spPr>
          <a:xfrm rot="10800000">
            <a:off x="7803051" y="922065"/>
            <a:ext cx="1406282" cy="369332"/>
          </a:xfrm>
          <a:prstGeom prst="rect">
            <a:avLst/>
          </a:prstGeom>
          <a:noFill/>
        </p:spPr>
        <p:txBody>
          <a:bodyPr vert="vert270" wrap="square" rtlCol="0" anchor="b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0</a:t>
            </a:r>
          </a:p>
          <a:p>
            <a:pPr algn="ctr"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8</a:t>
            </a:r>
          </a:p>
          <a:p>
            <a:pPr algn="ctr"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6</a:t>
            </a:r>
          </a:p>
          <a:p>
            <a:pPr algn="ctr"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4</a:t>
            </a:r>
          </a:p>
          <a:p>
            <a:pPr algn="ctr"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   </a:t>
            </a:r>
          </a:p>
          <a:p>
            <a:pPr algn="ctr"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967965" y="478135"/>
            <a:ext cx="863345" cy="323165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D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944856" y="449219"/>
            <a:ext cx="863345" cy="323165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D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555413" y="413672"/>
            <a:ext cx="863345" cy="323165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D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236091" y="736122"/>
            <a:ext cx="863345" cy="323165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D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922066" y="-89098"/>
            <a:ext cx="1125132" cy="498663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716048" y="-49565"/>
            <a:ext cx="239000" cy="498663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112980" y="-49444"/>
            <a:ext cx="239000" cy="498663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8345022" y="-73409"/>
            <a:ext cx="239000" cy="498663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52400" y="5010835"/>
            <a:ext cx="1194055" cy="323165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-8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253917" y="5010835"/>
            <a:ext cx="1147011" cy="323165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-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890032" y="5027082"/>
            <a:ext cx="1206289" cy="323165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-8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544816" y="5045345"/>
            <a:ext cx="1122947" cy="323165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-11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1884873" y="832183"/>
            <a:ext cx="2078177" cy="3885826"/>
            <a:chOff x="2335330" y="1559471"/>
            <a:chExt cx="2312428" cy="3176330"/>
          </a:xfrm>
        </p:grpSpPr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4"/>
            <a:srcRect l="12347" t="3389"/>
            <a:stretch>
              <a:fillRect/>
            </a:stretch>
          </p:blipFill>
          <p:spPr>
            <a:xfrm>
              <a:off x="3185119" y="1617693"/>
              <a:ext cx="1462639" cy="3023318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5"/>
            <a:srcRect t="16452"/>
            <a:stretch>
              <a:fillRect/>
            </a:stretch>
          </p:blipFill>
          <p:spPr>
            <a:xfrm>
              <a:off x="2335330" y="1559471"/>
              <a:ext cx="872255" cy="3176330"/>
            </a:xfrm>
            <a:prstGeom prst="rect">
              <a:avLst/>
            </a:prstGeom>
          </p:spPr>
        </p:pic>
      </p:grpSp>
      <p:sp>
        <p:nvSpPr>
          <p:cNvPr id="32" name="TextBox 31"/>
          <p:cNvSpPr txBox="1"/>
          <p:nvPr/>
        </p:nvSpPr>
        <p:spPr>
          <a:xfrm>
            <a:off x="5039196" y="394901"/>
            <a:ext cx="863345" cy="323165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D</a:t>
            </a:r>
          </a:p>
        </p:txBody>
      </p:sp>
      <p:sp>
        <p:nvSpPr>
          <p:cNvPr id="33" name="TextBox 32"/>
          <p:cNvSpPr txBox="1"/>
          <p:nvPr/>
        </p:nvSpPr>
        <p:spPr>
          <a:xfrm rot="10800000">
            <a:off x="2582818" y="667114"/>
            <a:ext cx="1250471" cy="369332"/>
          </a:xfrm>
          <a:prstGeom prst="rect">
            <a:avLst/>
          </a:prstGeom>
          <a:noFill/>
        </p:spPr>
        <p:txBody>
          <a:bodyPr vert="vert270" wrap="square" rtlCol="0" anchor="b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  <a:p>
            <a:pPr algn="ctr"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  <a:p>
            <a:pPr algn="ctr"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  <a:p>
            <a:pPr algn="ctr"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ctr">
              <a:lnSpc>
                <a:spcPct val="20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148243" y="5031770"/>
            <a:ext cx="1147011" cy="323165"/>
          </a:xfrm>
          <a:prstGeom prst="rect">
            <a:avLst/>
          </a:prstGeom>
          <a:noFill/>
        </p:spPr>
        <p:txBody>
          <a:bodyPr vert="horz" wrap="square" rtlCol="0" anchor="b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-1</a:t>
            </a: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6"/>
          <a:srcRect t="4423"/>
          <a:stretch>
            <a:fillRect/>
          </a:stretch>
        </p:blipFill>
        <p:spPr>
          <a:xfrm>
            <a:off x="5790196" y="832182"/>
            <a:ext cx="1664412" cy="3921505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 rot="10800000">
            <a:off x="6467048" y="600573"/>
            <a:ext cx="973215" cy="369332"/>
          </a:xfrm>
          <a:prstGeom prst="rect">
            <a:avLst/>
          </a:prstGeom>
          <a:noFill/>
        </p:spPr>
        <p:txBody>
          <a:bodyPr vert="vert270" wrap="square" rtlCol="0" anchor="b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  <a:p>
            <a:pPr algn="ctr">
              <a:lnSpc>
                <a:spcPct val="150000"/>
              </a:lnSpc>
            </a:pP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  <a:p>
            <a:pPr algn="ctr">
              <a:lnSpc>
                <a:spcPct val="150000"/>
              </a:lnSpc>
            </a:pP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  <a:p>
            <a:pPr algn="ctr">
              <a:lnSpc>
                <a:spcPct val="150000"/>
              </a:lnSpc>
            </a:pP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ctr">
              <a:lnSpc>
                <a:spcPct val="150000"/>
              </a:lnSpc>
            </a:pP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</a:t>
            </a:r>
          </a:p>
        </p:txBody>
      </p:sp>
    </p:spTree>
    <p:extLst>
      <p:ext uri="{BB962C8B-B14F-4D97-AF65-F5344CB8AC3E}">
        <p14:creationId xmlns:p14="http://schemas.microsoft.com/office/powerpoint/2010/main" val="3395970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ela Priency D.</dc:creator>
  <cp:lastModifiedBy>Anjela Priency D.</cp:lastModifiedBy>
  <cp:revision>1</cp:revision>
  <dcterms:created xsi:type="dcterms:W3CDTF">2021-09-02T09:31:04Z</dcterms:created>
  <dcterms:modified xsi:type="dcterms:W3CDTF">2021-09-02T09:31:33Z</dcterms:modified>
</cp:coreProperties>
</file>